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4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25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4012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2008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8738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69494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41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2874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685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9560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9601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8366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3493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D3BB1-6FAE-478A-99F0-4EAE8BF841C7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39713-5D16-4843-9F58-0081EC8B977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2518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647354-D169-43D7-B3F0-45833B01F99D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17" t="38885" r="18430" b="11362"/>
          <a:stretch/>
        </p:blipFill>
        <p:spPr bwMode="auto">
          <a:xfrm>
            <a:off x="1411404" y="1456267"/>
            <a:ext cx="7083192" cy="342237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E2B7F75-945A-491B-B5B7-FCD746AAA0E8}"/>
              </a:ext>
            </a:extLst>
          </p:cNvPr>
          <p:cNvSpPr txBox="1"/>
          <p:nvPr/>
        </p:nvSpPr>
        <p:spPr>
          <a:xfrm>
            <a:off x="721895" y="4878642"/>
            <a:ext cx="8633861" cy="10041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65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3. 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Semi-quantitative PCR for miRNA</a:t>
            </a:r>
            <a:r>
              <a:rPr lang="en-US" sz="1400" b="1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.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 Semi-quantitative PCR was carried out for miR395a and miR408-3p using specific primers for uninfected and infected samples at different time points post </a:t>
            </a:r>
            <a:r>
              <a:rPr lang="en-US" sz="1400" i="1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R. </a:t>
            </a:r>
            <a:r>
              <a:rPr lang="en-US" sz="1400" i="1" dirty="0" err="1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solani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 infection along with negative (water, RNA) and positive control (5.8s rRNA). Low range ladder (</a:t>
            </a:r>
            <a:r>
              <a:rPr lang="en-US" sz="1400" dirty="0">
                <a:ea typeface="Times New Roman" panose="02020603050405020304" pitchFamily="18" charset="0"/>
              </a:rPr>
              <a:t>25-700 bp) (Gene ruler, Thermo scientific) was used as reference marker.</a:t>
            </a:r>
            <a:endParaRPr lang="en-IN" sz="1400" dirty="0">
              <a:latin typeface="Calibri" panose="020F0502020204030204" pitchFamily="34" charset="0"/>
              <a:ea typeface="Calibri" panose="020F0502020204030204" pitchFamily="34" charset="0"/>
              <a:cs typeface="Latha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AE7F7C-746F-4C62-B82C-12BEE1A57942}"/>
              </a:ext>
            </a:extLst>
          </p:cNvPr>
          <p:cNvSpPr txBox="1"/>
          <p:nvPr/>
        </p:nvSpPr>
        <p:spPr>
          <a:xfrm>
            <a:off x="2586567" y="1170001"/>
            <a:ext cx="10287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miR395a</a:t>
            </a:r>
            <a:endParaRPr lang="en-IN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D3AD24-5ADA-4B49-AF12-C181B328033F}"/>
              </a:ext>
            </a:extLst>
          </p:cNvPr>
          <p:cNvSpPr txBox="1"/>
          <p:nvPr/>
        </p:nvSpPr>
        <p:spPr>
          <a:xfrm>
            <a:off x="6290735" y="1086934"/>
            <a:ext cx="13081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miR408-3p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1156581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72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RBAD GURIA</dc:creator>
  <cp:lastModifiedBy>Nagesh S</cp:lastModifiedBy>
  <cp:revision>7</cp:revision>
  <dcterms:created xsi:type="dcterms:W3CDTF">2022-02-04T02:17:03Z</dcterms:created>
  <dcterms:modified xsi:type="dcterms:W3CDTF">2022-02-04T09:30:58Z</dcterms:modified>
</cp:coreProperties>
</file>